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5" r:id="rId2"/>
    <p:sldId id="281" r:id="rId3"/>
    <p:sldId id="285" r:id="rId4"/>
    <p:sldId id="282" r:id="rId5"/>
    <p:sldId id="273" r:id="rId6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F41D6"/>
    <a:srgbClr val="99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353" autoAdjust="0"/>
    <p:restoredTop sz="94434" autoAdjust="0"/>
  </p:normalViewPr>
  <p:slideViewPr>
    <p:cSldViewPr snapToGrid="0">
      <p:cViewPr>
        <p:scale>
          <a:sx n="55" d="100"/>
          <a:sy n="55" d="100"/>
        </p:scale>
        <p:origin x="2178" y="33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39FD93-1E01-47BA-89E9-1FFAA23E01D9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3A2DA6-5639-4B93-94F5-BF5DB7F4C55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29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3A2DA6-5639-4B93-94F5-BF5DB7F4C55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0751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3A2DA6-5639-4B93-94F5-BF5DB7F4C55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1227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62" indent="0" algn="ctr">
              <a:buNone/>
              <a:defRPr sz="2000"/>
            </a:lvl2pPr>
            <a:lvl3pPr marL="914323" indent="0" algn="ctr">
              <a:buNone/>
              <a:defRPr sz="1800"/>
            </a:lvl3pPr>
            <a:lvl4pPr marL="1371486" indent="0" algn="ctr">
              <a:buNone/>
              <a:defRPr sz="1600"/>
            </a:lvl4pPr>
            <a:lvl5pPr marL="1828647" indent="0" algn="ctr">
              <a:buNone/>
              <a:defRPr sz="1600"/>
            </a:lvl5pPr>
            <a:lvl6pPr marL="2285809" indent="0" algn="ctr">
              <a:buNone/>
              <a:defRPr sz="1600"/>
            </a:lvl6pPr>
            <a:lvl7pPr marL="2742970" indent="0" algn="ctr">
              <a:buNone/>
              <a:defRPr sz="1600"/>
            </a:lvl7pPr>
            <a:lvl8pPr marL="3200132" indent="0" algn="ctr">
              <a:buNone/>
              <a:defRPr sz="1600"/>
            </a:lvl8pPr>
            <a:lvl9pPr marL="3657293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51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932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6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30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2" y="1709740"/>
            <a:ext cx="8543925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2" y="4589467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6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2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97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2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226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665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30" y="365127"/>
            <a:ext cx="8543925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62" indent="0">
              <a:buNone/>
              <a:defRPr sz="2000" b="1"/>
            </a:lvl2pPr>
            <a:lvl3pPr marL="914323" indent="0">
              <a:buNone/>
              <a:defRPr sz="1800" b="1"/>
            </a:lvl3pPr>
            <a:lvl4pPr marL="1371486" indent="0">
              <a:buNone/>
              <a:defRPr sz="1600" b="1"/>
            </a:lvl4pPr>
            <a:lvl5pPr marL="1828647" indent="0">
              <a:buNone/>
              <a:defRPr sz="1600" b="1"/>
            </a:lvl5pPr>
            <a:lvl6pPr marL="2285809" indent="0">
              <a:buNone/>
              <a:defRPr sz="1600" b="1"/>
            </a:lvl6pPr>
            <a:lvl7pPr marL="2742970" indent="0">
              <a:buNone/>
              <a:defRPr sz="1600" b="1"/>
            </a:lvl7pPr>
            <a:lvl8pPr marL="3200132" indent="0">
              <a:buNone/>
              <a:defRPr sz="1600" b="1"/>
            </a:lvl8pPr>
            <a:lvl9pPr marL="3657293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5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62" indent="0">
              <a:buNone/>
              <a:defRPr sz="2000" b="1"/>
            </a:lvl2pPr>
            <a:lvl3pPr marL="914323" indent="0">
              <a:buNone/>
              <a:defRPr sz="1800" b="1"/>
            </a:lvl3pPr>
            <a:lvl4pPr marL="1371486" indent="0">
              <a:buNone/>
              <a:defRPr sz="1600" b="1"/>
            </a:lvl4pPr>
            <a:lvl5pPr marL="1828647" indent="0">
              <a:buNone/>
              <a:defRPr sz="1600" b="1"/>
            </a:lvl5pPr>
            <a:lvl6pPr marL="2285809" indent="0">
              <a:buNone/>
              <a:defRPr sz="1600" b="1"/>
            </a:lvl6pPr>
            <a:lvl7pPr marL="2742970" indent="0">
              <a:buNone/>
              <a:defRPr sz="1600" b="1"/>
            </a:lvl7pPr>
            <a:lvl8pPr marL="3200132" indent="0">
              <a:buNone/>
              <a:defRPr sz="1600" b="1"/>
            </a:lvl8pPr>
            <a:lvl9pPr marL="3657293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5" y="2505076"/>
            <a:ext cx="4211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722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974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368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2" y="987429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2" indent="0">
              <a:buNone/>
              <a:defRPr sz="1400"/>
            </a:lvl2pPr>
            <a:lvl3pPr marL="914323" indent="0">
              <a:buNone/>
              <a:defRPr sz="1200"/>
            </a:lvl3pPr>
            <a:lvl4pPr marL="1371486" indent="0">
              <a:buNone/>
              <a:defRPr sz="1000"/>
            </a:lvl4pPr>
            <a:lvl5pPr marL="1828647" indent="0">
              <a:buNone/>
              <a:defRPr sz="1000"/>
            </a:lvl5pPr>
            <a:lvl6pPr marL="2285809" indent="0">
              <a:buNone/>
              <a:defRPr sz="1000"/>
            </a:lvl6pPr>
            <a:lvl7pPr marL="2742970" indent="0">
              <a:buNone/>
              <a:defRPr sz="1000"/>
            </a:lvl7pPr>
            <a:lvl8pPr marL="3200132" indent="0">
              <a:buNone/>
              <a:defRPr sz="1000"/>
            </a:lvl8pPr>
            <a:lvl9pPr marL="3657293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488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2" y="987429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62" indent="0">
              <a:buNone/>
              <a:defRPr sz="2799"/>
            </a:lvl2pPr>
            <a:lvl3pPr marL="914323" indent="0">
              <a:buNone/>
              <a:defRPr sz="2401"/>
            </a:lvl3pPr>
            <a:lvl4pPr marL="1371486" indent="0">
              <a:buNone/>
              <a:defRPr sz="2000"/>
            </a:lvl4pPr>
            <a:lvl5pPr marL="1828647" indent="0">
              <a:buNone/>
              <a:defRPr sz="2000"/>
            </a:lvl5pPr>
            <a:lvl6pPr marL="2285809" indent="0">
              <a:buNone/>
              <a:defRPr sz="2000"/>
            </a:lvl6pPr>
            <a:lvl7pPr marL="2742970" indent="0">
              <a:buNone/>
              <a:defRPr sz="2000"/>
            </a:lvl7pPr>
            <a:lvl8pPr marL="3200132" indent="0">
              <a:buNone/>
              <a:defRPr sz="2000"/>
            </a:lvl8pPr>
            <a:lvl9pPr marL="3657293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62" indent="0">
              <a:buNone/>
              <a:defRPr sz="1400"/>
            </a:lvl2pPr>
            <a:lvl3pPr marL="914323" indent="0">
              <a:buNone/>
              <a:defRPr sz="1200"/>
            </a:lvl3pPr>
            <a:lvl4pPr marL="1371486" indent="0">
              <a:buNone/>
              <a:defRPr sz="1000"/>
            </a:lvl4pPr>
            <a:lvl5pPr marL="1828647" indent="0">
              <a:buNone/>
              <a:defRPr sz="1000"/>
            </a:lvl5pPr>
            <a:lvl6pPr marL="2285809" indent="0">
              <a:buNone/>
              <a:defRPr sz="1000"/>
            </a:lvl6pPr>
            <a:lvl7pPr marL="2742970" indent="0">
              <a:buNone/>
              <a:defRPr sz="1000"/>
            </a:lvl7pPr>
            <a:lvl8pPr marL="3200132" indent="0">
              <a:buNone/>
              <a:defRPr sz="1000"/>
            </a:lvl8pPr>
            <a:lvl9pPr marL="3657293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08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40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40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E2B61-450C-4F8E-B0BF-EB0E6BFB823F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5" y="6356354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0FCB27-724B-407C-8D9F-CE8F1C10E015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709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32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2" indent="-228582" algn="l" defTabSz="91432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43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04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65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28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90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50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13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74" indent="-228582" algn="l" defTabSz="9143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62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23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86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47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09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70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32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93" algn="l" defTabSz="91432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ángulo 20"/>
          <p:cNvSpPr/>
          <p:nvPr/>
        </p:nvSpPr>
        <p:spPr>
          <a:xfrm>
            <a:off x="7172404" y="-146824"/>
            <a:ext cx="2614120" cy="24006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hylogenetic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e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LRT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-SH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ethod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hyML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utgroup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red.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are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tyhelminthe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lid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fic-clas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stoda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matoda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ey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ID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pt-B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pt-B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anulosus</a:t>
            </a:r>
            <a:r>
              <a:rPr lang="pt-B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e in color blue.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pt-B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274934" y="56272"/>
            <a:ext cx="13179118" cy="6858001"/>
          </a:xfrm>
          <a:prstGeom prst="rect">
            <a:avLst/>
          </a:prstGeom>
        </p:spPr>
      </p:pic>
      <p:sp>
        <p:nvSpPr>
          <p:cNvPr id="3" name="Rectángulo 2"/>
          <p:cNvSpPr/>
          <p:nvPr/>
        </p:nvSpPr>
        <p:spPr>
          <a:xfrm>
            <a:off x="6554312" y="4582012"/>
            <a:ext cx="349872" cy="2179208"/>
          </a:xfrm>
          <a:prstGeom prst="rect">
            <a:avLst/>
          </a:prstGeom>
          <a:solidFill>
            <a:srgbClr val="FF00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ángulo 4"/>
          <p:cNvSpPr/>
          <p:nvPr/>
        </p:nvSpPr>
        <p:spPr>
          <a:xfrm>
            <a:off x="6554312" y="56273"/>
            <a:ext cx="349872" cy="954907"/>
          </a:xfrm>
          <a:prstGeom prst="rect">
            <a:avLst/>
          </a:prstGeom>
          <a:solidFill>
            <a:srgbClr val="FFFF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ángulo 5"/>
          <p:cNvSpPr/>
          <p:nvPr/>
        </p:nvSpPr>
        <p:spPr>
          <a:xfrm>
            <a:off x="6554312" y="2814013"/>
            <a:ext cx="349872" cy="661940"/>
          </a:xfrm>
          <a:prstGeom prst="rect">
            <a:avLst/>
          </a:prstGeom>
          <a:solidFill>
            <a:srgbClr val="00B05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ángulo 6"/>
          <p:cNvSpPr/>
          <p:nvPr/>
        </p:nvSpPr>
        <p:spPr>
          <a:xfrm>
            <a:off x="6554312" y="3469286"/>
            <a:ext cx="349872" cy="856529"/>
          </a:xfrm>
          <a:prstGeom prst="rect">
            <a:avLst/>
          </a:prstGeom>
          <a:solidFill>
            <a:schemeClr val="bg1">
              <a:lumMod val="75000"/>
              <a:alpha val="2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448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ángulo 18"/>
          <p:cNvSpPr/>
          <p:nvPr/>
        </p:nvSpPr>
        <p:spPr>
          <a:xfrm>
            <a:off x="7061200" y="-148034"/>
            <a:ext cx="28448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hylogenetic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e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ayesian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nference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EAST v1.8.4.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utgroup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in red.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har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latyhelminthe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nelid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pecific-clas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Cestoda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rematoda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grey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ID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pt-BR" sz="1000" i="1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pt-BR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granulosus</a:t>
            </a:r>
            <a:r>
              <a:rPr lang="pt-BR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are in color blue.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447320" y="0"/>
            <a:ext cx="13464112" cy="7006590"/>
          </a:xfrm>
          <a:prstGeom prst="rect">
            <a:avLst/>
          </a:prstGeom>
        </p:spPr>
      </p:pic>
      <p:sp>
        <p:nvSpPr>
          <p:cNvPr id="4" name="Rectángulo 3"/>
          <p:cNvSpPr/>
          <p:nvPr/>
        </p:nvSpPr>
        <p:spPr>
          <a:xfrm>
            <a:off x="6651667" y="4657163"/>
            <a:ext cx="349872" cy="2179208"/>
          </a:xfrm>
          <a:prstGeom prst="rect">
            <a:avLst/>
          </a:prstGeom>
          <a:solidFill>
            <a:srgbClr val="FF00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ángulo 4"/>
          <p:cNvSpPr/>
          <p:nvPr/>
        </p:nvSpPr>
        <p:spPr>
          <a:xfrm>
            <a:off x="6655144" y="9729"/>
            <a:ext cx="349872" cy="989293"/>
          </a:xfrm>
          <a:prstGeom prst="rect">
            <a:avLst/>
          </a:prstGeom>
          <a:solidFill>
            <a:srgbClr val="FFFF0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ángulo 5"/>
          <p:cNvSpPr/>
          <p:nvPr/>
        </p:nvSpPr>
        <p:spPr>
          <a:xfrm>
            <a:off x="6651667" y="2497122"/>
            <a:ext cx="349872" cy="279900"/>
          </a:xfrm>
          <a:prstGeom prst="rect">
            <a:avLst/>
          </a:prstGeom>
          <a:solidFill>
            <a:srgbClr val="00B05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ángulo 6"/>
          <p:cNvSpPr/>
          <p:nvPr/>
        </p:nvSpPr>
        <p:spPr>
          <a:xfrm>
            <a:off x="6651667" y="2777023"/>
            <a:ext cx="349872" cy="777240"/>
          </a:xfrm>
          <a:prstGeom prst="rect">
            <a:avLst/>
          </a:prstGeom>
          <a:solidFill>
            <a:schemeClr val="bg1">
              <a:lumMod val="75000"/>
              <a:alpha val="2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ángulo 7"/>
          <p:cNvSpPr/>
          <p:nvPr/>
        </p:nvSpPr>
        <p:spPr>
          <a:xfrm>
            <a:off x="6649569" y="3739972"/>
            <a:ext cx="349872" cy="426430"/>
          </a:xfrm>
          <a:prstGeom prst="rect">
            <a:avLst/>
          </a:prstGeom>
          <a:solidFill>
            <a:srgbClr val="00B050">
              <a:alpha val="26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ángulo 8"/>
          <p:cNvSpPr/>
          <p:nvPr/>
        </p:nvSpPr>
        <p:spPr>
          <a:xfrm>
            <a:off x="6649569" y="4166402"/>
            <a:ext cx="349872" cy="370840"/>
          </a:xfrm>
          <a:prstGeom prst="rect">
            <a:avLst/>
          </a:prstGeom>
          <a:solidFill>
            <a:schemeClr val="bg1">
              <a:lumMod val="75000"/>
              <a:alpha val="2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4933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0596" y="3476066"/>
            <a:ext cx="1773733" cy="13588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agen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3661" y="5037183"/>
            <a:ext cx="1783574" cy="13752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55811" y="5042518"/>
            <a:ext cx="1725759" cy="13699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17467" y="5044217"/>
            <a:ext cx="1772109" cy="13682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45129" y="3479980"/>
            <a:ext cx="1735793" cy="13636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Rectángulo 10"/>
          <p:cNvSpPr/>
          <p:nvPr/>
        </p:nvSpPr>
        <p:spPr>
          <a:xfrm>
            <a:off x="3165514" y="3267263"/>
            <a:ext cx="17915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sp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1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ángulo 11"/>
          <p:cNvSpPr/>
          <p:nvPr/>
        </p:nvSpPr>
        <p:spPr>
          <a:xfrm>
            <a:off x="6830248" y="3262148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12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ángulo 12"/>
          <p:cNvSpPr/>
          <p:nvPr/>
        </p:nvSpPr>
        <p:spPr>
          <a:xfrm>
            <a:off x="1440615" y="4821429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13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ángulo 13"/>
          <p:cNvSpPr/>
          <p:nvPr/>
        </p:nvSpPr>
        <p:spPr>
          <a:xfrm>
            <a:off x="3241261" y="4824636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 14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ángulo 14"/>
          <p:cNvSpPr/>
          <p:nvPr/>
        </p:nvSpPr>
        <p:spPr>
          <a:xfrm>
            <a:off x="5053551" y="4825196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Ser 14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ángulo 16"/>
          <p:cNvSpPr/>
          <p:nvPr/>
        </p:nvSpPr>
        <p:spPr>
          <a:xfrm>
            <a:off x="595932" y="480659"/>
            <a:ext cx="7531936" cy="60767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ángulo 18"/>
          <p:cNvSpPr/>
          <p:nvPr/>
        </p:nvSpPr>
        <p:spPr>
          <a:xfrm>
            <a:off x="595930" y="619160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ángulo 19"/>
          <p:cNvSpPr/>
          <p:nvPr/>
        </p:nvSpPr>
        <p:spPr>
          <a:xfrm>
            <a:off x="5521884" y="619159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ángulo 20"/>
          <p:cNvSpPr/>
          <p:nvPr/>
        </p:nvSpPr>
        <p:spPr>
          <a:xfrm>
            <a:off x="595930" y="2990264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Imagen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0897" y="3476346"/>
            <a:ext cx="1770084" cy="13672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Rectángulo 22"/>
          <p:cNvSpPr/>
          <p:nvPr/>
        </p:nvSpPr>
        <p:spPr>
          <a:xfrm>
            <a:off x="1411879" y="3259966"/>
            <a:ext cx="18104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Pro 1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Imagen 2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23036" y="3476345"/>
            <a:ext cx="1743413" cy="13672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Rectángulo 24"/>
          <p:cNvSpPr/>
          <p:nvPr/>
        </p:nvSpPr>
        <p:spPr>
          <a:xfrm>
            <a:off x="5043161" y="3257844"/>
            <a:ext cx="18104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Val 4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Imagen 2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28151" y="5037181"/>
            <a:ext cx="1756177" cy="13665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Rectángulo 26"/>
          <p:cNvSpPr/>
          <p:nvPr/>
        </p:nvSpPr>
        <p:spPr>
          <a:xfrm>
            <a:off x="6831853" y="4812824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>
                <a:latin typeface="Arial" panose="020B0604020202020204" pitchFamily="34" charset="0"/>
                <a:cs typeface="Arial" panose="020B0604020202020204" pitchFamily="34" charset="0"/>
              </a:rPr>
              <a:t>Ser 14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o 9"/>
          <p:cNvGrpSpPr/>
          <p:nvPr/>
        </p:nvGrpSpPr>
        <p:grpSpPr>
          <a:xfrm>
            <a:off x="6036055" y="735594"/>
            <a:ext cx="1628355" cy="2218821"/>
            <a:chOff x="1246132" y="757657"/>
            <a:chExt cx="1628355" cy="2218820"/>
          </a:xfrm>
        </p:grpSpPr>
        <p:pic>
          <p:nvPicPr>
            <p:cNvPr id="30" name="Imagen 29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20703" y="757657"/>
              <a:ext cx="1479213" cy="22188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CuadroTexto 5"/>
            <p:cNvSpPr txBox="1"/>
            <p:nvPr/>
          </p:nvSpPr>
          <p:spPr>
            <a:xfrm>
              <a:off x="2227716" y="798226"/>
              <a:ext cx="646771" cy="184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599" dirty="0" err="1">
                  <a:latin typeface="Arial" panose="020B0604020202020204" pitchFamily="34" charset="0"/>
                  <a:cs typeface="Arial" panose="020B0604020202020204" pitchFamily="34" charset="0"/>
                </a:rPr>
                <a:t>Large</a:t>
              </a:r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599" dirty="0" err="1">
                  <a:latin typeface="Arial" panose="020B0604020202020204" pitchFamily="34" charset="0"/>
                  <a:cs typeface="Arial" panose="020B0604020202020204" pitchFamily="34" charset="0"/>
                </a:rPr>
                <a:t>coil</a:t>
              </a:r>
              <a:endParaRPr lang="en-US" sz="59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2213515" y="2718979"/>
              <a:ext cx="646771" cy="184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pt-BR" sz="599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599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pt-BR" sz="599" dirty="0" err="1">
                  <a:latin typeface="Arial" panose="020B0604020202020204" pitchFamily="34" charset="0"/>
                  <a:cs typeface="Arial" panose="020B0604020202020204" pitchFamily="34" charset="0"/>
                </a:rPr>
                <a:t>sheet</a:t>
              </a:r>
              <a:endParaRPr lang="en-US" sz="59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1246132" y="1438107"/>
              <a:ext cx="646771" cy="184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pt-BR" sz="599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599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pt-BR" sz="599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pt-BR" sz="599" dirty="0" err="1">
                  <a:latin typeface="Arial" panose="020B0604020202020204" pitchFamily="34" charset="0"/>
                  <a:cs typeface="Arial" panose="020B0604020202020204" pitchFamily="34" charset="0"/>
                </a:rPr>
                <a:t>sheet</a:t>
              </a:r>
              <a:endParaRPr lang="en-US" sz="59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Conector recto de flecha 7"/>
            <p:cNvCxnSpPr/>
            <p:nvPr/>
          </p:nvCxnSpPr>
          <p:spPr>
            <a:xfrm>
              <a:off x="1524599" y="1622774"/>
              <a:ext cx="192232" cy="79439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Conector recto de flecha 30"/>
            <p:cNvCxnSpPr/>
            <p:nvPr/>
          </p:nvCxnSpPr>
          <p:spPr>
            <a:xfrm flipH="1" flipV="1">
              <a:off x="1904018" y="2495295"/>
              <a:ext cx="369866" cy="30593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Conector recto de flecha 31"/>
            <p:cNvCxnSpPr/>
            <p:nvPr/>
          </p:nvCxnSpPr>
          <p:spPr>
            <a:xfrm flipH="1">
              <a:off x="2153145" y="953752"/>
              <a:ext cx="279584" cy="1541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7" name="Imagen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90202" y="673565"/>
            <a:ext cx="3315090" cy="2321011"/>
          </a:xfrm>
          <a:prstGeom prst="rect">
            <a:avLst/>
          </a:prstGeom>
        </p:spPr>
      </p:pic>
      <p:graphicFrame>
        <p:nvGraphicFramePr>
          <p:cNvPr id="22" name="Tabla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4381600"/>
              </p:ext>
            </p:extLst>
          </p:nvPr>
        </p:nvGraphicFramePr>
        <p:xfrm>
          <a:off x="4265936" y="1531530"/>
          <a:ext cx="899908" cy="6122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9908"/>
              </a:tblGrid>
              <a:tr h="36576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9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fidence</a:t>
                      </a:r>
                      <a:r>
                        <a:rPr lang="pt-BR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9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</a:t>
                      </a:r>
                      <a:r>
                        <a:rPr lang="pt-BR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-</a:t>
                      </a:r>
                      <a:r>
                        <a:rPr lang="pt-BR" sz="9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en-US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1" marR="9144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46463">
                <a:tc>
                  <a:txBody>
                    <a:bodyPr/>
                    <a:lstStyle/>
                    <a:p>
                      <a:pPr algn="ctr"/>
                      <a:r>
                        <a:rPr lang="pt-BR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91E-4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1" marR="9144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6" name="Tabla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4409738"/>
              </p:ext>
            </p:extLst>
          </p:nvPr>
        </p:nvGraphicFramePr>
        <p:xfrm>
          <a:off x="4265936" y="722721"/>
          <a:ext cx="899908" cy="74938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9908"/>
              </a:tblGrid>
              <a:tr h="502920">
                <a:tc>
                  <a:txBody>
                    <a:bodyPr/>
                    <a:lstStyle/>
                    <a:p>
                      <a:pPr algn="ctr"/>
                      <a:r>
                        <a:rPr lang="pt-BR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obal</a:t>
                      </a:r>
                      <a:r>
                        <a:rPr lang="pt-BR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900" baseline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</a:t>
                      </a:r>
                      <a:r>
                        <a:rPr lang="pt-BR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900" baseline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ality</a:t>
                      </a:r>
                      <a:r>
                        <a:rPr lang="pt-BR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core</a:t>
                      </a:r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1" marR="9144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46463">
                <a:tc>
                  <a:txBody>
                    <a:bodyPr/>
                    <a:lstStyle/>
                    <a:p>
                      <a:pPr algn="ctr"/>
                      <a:r>
                        <a:rPr lang="pt-BR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77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41" marR="9144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34" name="Rectángulo 33"/>
          <p:cNvSpPr/>
          <p:nvPr/>
        </p:nvSpPr>
        <p:spPr>
          <a:xfrm>
            <a:off x="8124012" y="117887"/>
            <a:ext cx="1672512" cy="51706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EgrG_08736 3D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odeling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3D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quality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ModFOL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v4.0. (B)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btain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MJ05877 USP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Methanococcus</a:t>
            </a:r>
            <a:r>
              <a:rPr lang="pt-BR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jannaschii</a:t>
            </a:r>
            <a:r>
              <a:rPr lang="pt-BR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as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emplate</a:t>
            </a:r>
            <a:r>
              <a:rPr lang="pt-B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color ar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ATP-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sites. Th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larg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coi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top)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correspo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insertio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query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u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model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loca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ir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beta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heet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. (C)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Lig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sites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hyr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v2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Investigator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. For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amino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residu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referenc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per position (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al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favourabl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, short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blue=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unfavourabl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mutation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al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likely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, short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blue=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unlikely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ffec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pt-B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45886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8440" y="59985"/>
            <a:ext cx="216738" cy="114783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9646" y="81149"/>
            <a:ext cx="736813" cy="75679"/>
          </a:xfrm>
          <a:prstGeom prst="rect">
            <a:avLst/>
          </a:prstGeom>
        </p:spPr>
      </p:pic>
      <p:sp>
        <p:nvSpPr>
          <p:cNvPr id="12" name="Rectángulo 11"/>
          <p:cNvSpPr/>
          <p:nvPr/>
        </p:nvSpPr>
        <p:spPr>
          <a:xfrm>
            <a:off x="3529651" y="4106"/>
            <a:ext cx="339641" cy="756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ángulo 16"/>
          <p:cNvSpPr/>
          <p:nvPr/>
        </p:nvSpPr>
        <p:spPr>
          <a:xfrm>
            <a:off x="2004127" y="-42278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ángulo 19"/>
          <p:cNvSpPr/>
          <p:nvPr/>
        </p:nvSpPr>
        <p:spPr>
          <a:xfrm>
            <a:off x="2307773" y="-40084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Imagen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1755" y="78918"/>
            <a:ext cx="774948" cy="75679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7462" y="77956"/>
            <a:ext cx="849236" cy="75679"/>
          </a:xfrm>
          <a:prstGeom prst="rect">
            <a:avLst/>
          </a:prstGeom>
        </p:spPr>
      </p:pic>
      <p:sp>
        <p:nvSpPr>
          <p:cNvPr id="24" name="Rectángulo 23"/>
          <p:cNvSpPr/>
          <p:nvPr/>
        </p:nvSpPr>
        <p:spPr>
          <a:xfrm>
            <a:off x="5690374" y="48114"/>
            <a:ext cx="666678" cy="134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5" name="Imagen 2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39063" y="65769"/>
            <a:ext cx="266634" cy="114783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1510" y="82073"/>
            <a:ext cx="831803" cy="75679"/>
          </a:xfrm>
          <a:prstGeom prst="rect">
            <a:avLst/>
          </a:prstGeom>
        </p:spPr>
      </p:pic>
      <p:sp>
        <p:nvSpPr>
          <p:cNvPr id="28" name="Rectángulo 27"/>
          <p:cNvSpPr/>
          <p:nvPr/>
        </p:nvSpPr>
        <p:spPr>
          <a:xfrm>
            <a:off x="7259051" y="-53184"/>
            <a:ext cx="551815" cy="134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ángulo 29"/>
          <p:cNvSpPr/>
          <p:nvPr/>
        </p:nvSpPr>
        <p:spPr>
          <a:xfrm>
            <a:off x="4391628" y="-44330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ángulo 31"/>
          <p:cNvSpPr/>
          <p:nvPr/>
        </p:nvSpPr>
        <p:spPr>
          <a:xfrm>
            <a:off x="5415266" y="-46267"/>
            <a:ext cx="272436" cy="1845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ángulo 32"/>
          <p:cNvSpPr/>
          <p:nvPr/>
        </p:nvSpPr>
        <p:spPr>
          <a:xfrm>
            <a:off x="5727843" y="-38579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ángulo 33"/>
          <p:cNvSpPr/>
          <p:nvPr/>
        </p:nvSpPr>
        <p:spPr>
          <a:xfrm>
            <a:off x="6162244" y="-39202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ángulo 35"/>
          <p:cNvSpPr/>
          <p:nvPr/>
        </p:nvSpPr>
        <p:spPr>
          <a:xfrm>
            <a:off x="2591365" y="78918"/>
            <a:ext cx="681895" cy="756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ángulo 36"/>
          <p:cNvSpPr/>
          <p:nvPr/>
        </p:nvSpPr>
        <p:spPr>
          <a:xfrm>
            <a:off x="7842076" y="-50609"/>
            <a:ext cx="1909909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pt-B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enerate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hylogenetic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es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top,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chematiz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condary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3D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. Note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hipervariabl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eta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ra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lpha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lix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pt-B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2681" y="178771"/>
            <a:ext cx="6760044" cy="6653518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3217" y="58818"/>
            <a:ext cx="261780" cy="114783"/>
          </a:xfrm>
          <a:prstGeom prst="rect">
            <a:avLst/>
          </a:prstGeom>
        </p:spPr>
      </p:pic>
      <p:sp>
        <p:nvSpPr>
          <p:cNvPr id="18" name="Rectángulo 17"/>
          <p:cNvSpPr/>
          <p:nvPr/>
        </p:nvSpPr>
        <p:spPr>
          <a:xfrm>
            <a:off x="2760562" y="-41423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ángulo 37"/>
          <p:cNvSpPr/>
          <p:nvPr/>
        </p:nvSpPr>
        <p:spPr>
          <a:xfrm>
            <a:off x="4823827" y="66949"/>
            <a:ext cx="382174" cy="756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Imagen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9556" y="58818"/>
            <a:ext cx="429289" cy="123629"/>
          </a:xfrm>
          <a:prstGeom prst="rect">
            <a:avLst/>
          </a:prstGeom>
        </p:spPr>
      </p:pic>
      <p:sp>
        <p:nvSpPr>
          <p:cNvPr id="31" name="Rectángulo 30"/>
          <p:cNvSpPr/>
          <p:nvPr/>
        </p:nvSpPr>
        <p:spPr>
          <a:xfrm>
            <a:off x="4940627" y="-38579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ángulo 38"/>
          <p:cNvSpPr/>
          <p:nvPr/>
        </p:nvSpPr>
        <p:spPr>
          <a:xfrm>
            <a:off x="6438260" y="19564"/>
            <a:ext cx="666678" cy="134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9" name="Imagen 2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2189" y="63603"/>
            <a:ext cx="491124" cy="114783"/>
          </a:xfrm>
          <a:prstGeom prst="rect">
            <a:avLst/>
          </a:prstGeom>
        </p:spPr>
      </p:pic>
      <p:sp>
        <p:nvSpPr>
          <p:cNvPr id="35" name="Rectángulo 34"/>
          <p:cNvSpPr/>
          <p:nvPr/>
        </p:nvSpPr>
        <p:spPr>
          <a:xfrm>
            <a:off x="6582057" y="-35624"/>
            <a:ext cx="274434" cy="1845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599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BR" sz="599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5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uadroTexto 2"/>
          <p:cNvSpPr txBox="1"/>
          <p:nvPr/>
        </p:nvSpPr>
        <p:spPr>
          <a:xfrm>
            <a:off x="797830" y="136229"/>
            <a:ext cx="1339278" cy="68095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3767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4226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4288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4393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4567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5680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6342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7787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A_07834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164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381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425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446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4734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5974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597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5976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5976_bis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7259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795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7956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7956_bis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826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8264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826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8267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826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0839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1468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1468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1468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1599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1999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238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2384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2387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238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263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513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650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652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652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662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698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698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GI_10027596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G22118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G22323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6172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6375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7118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7232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72559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78947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8759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192836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0216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0968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0984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1111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1234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12839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1340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051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0518_bis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118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118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156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1973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5081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5107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536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apteP22816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0632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4032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789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7892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7893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7894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7895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8914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917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990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0991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1003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1004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10043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12002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12617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11301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CsinSc585new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D_00276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085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093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1233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4363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5343a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5343b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5343c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5343d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705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716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819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can_0923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620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725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7797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811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8734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8735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873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873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901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0983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1076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grG_2024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0653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620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725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7797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811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8734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8735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873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873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9018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0983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EmuJ_1076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Gsa0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Gsa02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Gsa0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Gsa04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Gsa05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Gsa06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6240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6332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6559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7352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7768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8484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85040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86168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88754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90749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92415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94412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194477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elroG65703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0323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0324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0990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1226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0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1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2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3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4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5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5627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6308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7746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8518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9725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HmN_09872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49221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64562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65224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65237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66166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67972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186269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03658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03798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04747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31833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34012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34396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LgigG238066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2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5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6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8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09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2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4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5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6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7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18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2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2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25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26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29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30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32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3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34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37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2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5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6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7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48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50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5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55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58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60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6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6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64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68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70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7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73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77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78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81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Mli82    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06200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06268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13248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15120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15122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16265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23291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25064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Ocbimv22030262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00574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00589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09166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11836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13960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21576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22303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22940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24145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26767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27288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30243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31148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31762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31763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39010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U15039964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00100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03130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04312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07640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09793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13687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13689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20024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20269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Smp_20572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031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1174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76a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77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78a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78b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7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80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8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2182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3499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4215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5585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08146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12941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265_13453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3450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3451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4573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5240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7188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7401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8641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09222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10056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10422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11924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12052        </a:t>
            </a:r>
          </a:p>
          <a:p>
            <a:r>
              <a:rPr lang="en-US" sz="150" dirty="0">
                <a:latin typeface="Arial" panose="020B0604020202020204" pitchFamily="34" charset="0"/>
                <a:cs typeface="Arial" panose="020B0604020202020204" pitchFamily="34" charset="0"/>
              </a:rPr>
              <a:t>TsM_12053 </a:t>
            </a:r>
          </a:p>
        </p:txBody>
      </p:sp>
    </p:spTree>
    <p:extLst>
      <p:ext uri="{BB962C8B-B14F-4D97-AF65-F5344CB8AC3E}">
        <p14:creationId xmlns:p14="http://schemas.microsoft.com/office/powerpoint/2010/main" val="4025849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ángulo 18"/>
          <p:cNvSpPr/>
          <p:nvPr/>
        </p:nvSpPr>
        <p:spPr>
          <a:xfrm>
            <a:off x="272575" y="2133920"/>
            <a:ext cx="930734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estoda</a:t>
            </a:r>
            <a:r>
              <a:rPr lang="pt-B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r>
              <a:rPr lang="pt-B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Codon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0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 as input for 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ML </a:t>
            </a:r>
            <a:r>
              <a:rPr lang="pt-B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ELECTON.</a:t>
            </a:r>
            <a:endParaRPr lang="pt-B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pt-B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m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795" y="296494"/>
            <a:ext cx="9069127" cy="1723135"/>
          </a:xfrm>
          <a:prstGeom prst="rect">
            <a:avLst/>
          </a:prstGeom>
        </p:spPr>
      </p:pic>
      <p:sp>
        <p:nvSpPr>
          <p:cNvPr id="3" name="CaixaDeTexto 2"/>
          <p:cNvSpPr txBox="1"/>
          <p:nvPr/>
        </p:nvSpPr>
        <p:spPr>
          <a:xfrm>
            <a:off x="272575" y="247686"/>
            <a:ext cx="361374" cy="1837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0851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725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725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4573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7746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9231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10769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10769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10422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6308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0936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901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901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7401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8518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1233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5240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6206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6206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9872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5343a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8734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8734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12053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5343d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873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873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3451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5627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5620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12052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5622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7050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20248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0653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11924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0990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5343c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8736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8736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3450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5625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4363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7797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7797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10056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0324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7161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8111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8111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8641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9725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5624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8199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9839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9839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9222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1226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can_05343b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grG_08735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EmuJ_08735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TsM_07188  </a:t>
            </a:r>
          </a:p>
          <a:p>
            <a:r>
              <a:rPr lang="pt-BR" sz="180" dirty="0">
                <a:latin typeface="Arial" panose="020B0604020202020204" pitchFamily="34" charset="0"/>
                <a:cs typeface="Arial" panose="020B0604020202020204" pitchFamily="34" charset="0"/>
              </a:rPr>
              <a:t>HmN_05623 </a:t>
            </a:r>
          </a:p>
        </p:txBody>
      </p:sp>
    </p:spTree>
    <p:extLst>
      <p:ext uri="{BB962C8B-B14F-4D97-AF65-F5344CB8AC3E}">
        <p14:creationId xmlns:p14="http://schemas.microsoft.com/office/powerpoint/2010/main" val="18746166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64</TotalTime>
  <Words>723</Words>
  <Application>Microsoft Office PowerPoint</Application>
  <PresentationFormat>A4 (210 x 297 mm)</PresentationFormat>
  <Paragraphs>397</Paragraphs>
  <Slides>5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ergio Martin Espinola</dc:creator>
  <cp:lastModifiedBy>Sergio Martin Espinola</cp:lastModifiedBy>
  <cp:revision>265</cp:revision>
  <dcterms:created xsi:type="dcterms:W3CDTF">2016-10-20T13:18:23Z</dcterms:created>
  <dcterms:modified xsi:type="dcterms:W3CDTF">2017-10-02T15:54:40Z</dcterms:modified>
</cp:coreProperties>
</file>